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6" d="100"/>
          <a:sy n="116" d="100"/>
        </p:scale>
        <p:origin x="355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4424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92785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5879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4911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7957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960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13682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71326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0857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75402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9299933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BC02AF-870E-4517-872C-BBBC581FB58F}" type="datetimeFigureOut">
              <a:rPr lang="en-GB" smtClean="0"/>
              <a:t>08/11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0F52F3-72A6-411C-B6E4-2671844694E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2085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.jpg"/>
   <Relationship Id="rId3" Type="http://schemas.openxmlformats.org/officeDocument/2006/relationships/image" Target="../media/image2.jpg"/>
   <Relationship Id="rId4" Type="http://schemas.openxmlformats.org/officeDocument/2006/relationships/image" Target="../media/image3.jpg"/>
   <Relationship Id="rId5" Type="http://schemas.openxmlformats.org/officeDocument/2006/relationships/image" Target="../media/image4.jpe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30" t="85424" r="1839" b="3535"/>
          <a:stretch/>
        </p:blipFill>
        <p:spPr>
          <a:xfrm>
            <a:off x="2217924" y="1067883"/>
            <a:ext cx="1800000" cy="274929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1195081" y="1030491"/>
            <a:ext cx="10790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Z-F &amp; R</a:t>
            </a:r>
            <a:endParaRPr lang="en-GB" sz="16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Picture 2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6" t="74337" r="3623" b="15340"/>
          <a:stretch/>
        </p:blipFill>
        <p:spPr>
          <a:xfrm>
            <a:off x="2217924" y="1414002"/>
            <a:ext cx="1800000" cy="292552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1195081" y="1373641"/>
            <a:ext cx="10790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W-F &amp; R</a:t>
            </a:r>
            <a:endParaRPr lang="en-GB" sz="16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Picture 2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888" t="50184" r="709" b="39180"/>
          <a:stretch/>
        </p:blipFill>
        <p:spPr>
          <a:xfrm>
            <a:off x="2217924" y="1777744"/>
            <a:ext cx="1800000" cy="233521"/>
          </a:xfrm>
          <a:prstGeom prst="rect">
            <a:avLst/>
          </a:prstGeom>
        </p:spPr>
      </p:pic>
      <p:sp>
        <p:nvSpPr>
          <p:cNvPr id="25" name="TextBox 24"/>
          <p:cNvSpPr txBox="1"/>
          <p:nvPr/>
        </p:nvSpPr>
        <p:spPr>
          <a:xfrm>
            <a:off x="1099502" y="1716791"/>
            <a:ext cx="11746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Z-F &amp; W-R</a:t>
            </a:r>
            <a:endParaRPr lang="en-GB" sz="16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13" t="62969" r="47842" b="34122"/>
          <a:stretch/>
        </p:blipFill>
        <p:spPr>
          <a:xfrm>
            <a:off x="2217924" y="2082455"/>
            <a:ext cx="1800000" cy="296701"/>
          </a:xfrm>
          <a:prstGeom prst="rect">
            <a:avLst/>
          </a:prstGeom>
        </p:spPr>
      </p:pic>
      <p:sp>
        <p:nvSpPr>
          <p:cNvPr id="34" name="TextBox 33"/>
          <p:cNvSpPr txBox="1"/>
          <p:nvPr/>
        </p:nvSpPr>
        <p:spPr>
          <a:xfrm>
            <a:off x="54907" y="2059942"/>
            <a:ext cx="22192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Z_link</a:t>
            </a:r>
            <a:r>
              <a:rPr lang="en-GB" sz="16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F &amp; </a:t>
            </a:r>
            <a:r>
              <a:rPr lang="en-GB" sz="1600" dirty="0" err="1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W_link</a:t>
            </a:r>
            <a:r>
              <a:rPr lang="en-GB" sz="16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R</a:t>
            </a:r>
            <a:endParaRPr lang="en-GB" sz="16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3929763" y="1011756"/>
            <a:ext cx="10790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- 141 </a:t>
            </a:r>
            <a:r>
              <a:rPr lang="en-GB" sz="16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GB" sz="16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929763" y="1372823"/>
            <a:ext cx="107906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- 151 </a:t>
            </a:r>
            <a:r>
              <a:rPr lang="en-GB" sz="16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GB" sz="16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929763" y="1717778"/>
            <a:ext cx="30383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- 1141; 1171; 1198 </a:t>
            </a:r>
            <a:r>
              <a:rPr lang="en-GB" sz="16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GB" sz="16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929763" y="2059645"/>
            <a:ext cx="30383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- 132; 162; 189 </a:t>
            </a:r>
            <a:r>
              <a:rPr lang="en-GB" sz="1600" dirty="0" err="1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6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n-GB" sz="16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0" name="Picture 3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549" t="63767" r="27483" b="33673"/>
          <a:stretch/>
        </p:blipFill>
        <p:spPr>
          <a:xfrm>
            <a:off x="2217924" y="2469686"/>
            <a:ext cx="1800000" cy="256419"/>
          </a:xfrm>
          <a:prstGeom prst="rect">
            <a:avLst/>
          </a:prstGeom>
        </p:spPr>
      </p:pic>
      <p:sp>
        <p:nvSpPr>
          <p:cNvPr id="41" name="TextBox 40"/>
          <p:cNvSpPr txBox="1"/>
          <p:nvPr/>
        </p:nvSpPr>
        <p:spPr>
          <a:xfrm>
            <a:off x="1534931" y="2428618"/>
            <a:ext cx="7392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6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GB" sz="1600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929763" y="2387551"/>
            <a:ext cx="137888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-- 84 </a:t>
            </a:r>
            <a:r>
              <a:rPr lang="en-GB" sz="1600" dirty="0" err="1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GB" sz="1600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 rot="16200000">
            <a:off x="2064448" y="648648"/>
            <a:ext cx="6531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-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Ø</a:t>
            </a:r>
            <a:endParaRPr lang="en-GB" sz="1600" dirty="0"/>
          </a:p>
        </p:txBody>
      </p:sp>
      <p:sp>
        <p:nvSpPr>
          <p:cNvPr id="43" name="TextBox 42"/>
          <p:cNvSpPr txBox="1"/>
          <p:nvPr/>
        </p:nvSpPr>
        <p:spPr>
          <a:xfrm rot="16200000">
            <a:off x="2243403" y="479314"/>
            <a:ext cx="991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-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Z+W</a:t>
            </a:r>
            <a:endParaRPr lang="en-GB" sz="1600" dirty="0"/>
          </a:p>
        </p:txBody>
      </p:sp>
      <p:sp>
        <p:nvSpPr>
          <p:cNvPr id="46" name="TextBox 45"/>
          <p:cNvSpPr txBox="1"/>
          <p:nvPr/>
        </p:nvSpPr>
        <p:spPr>
          <a:xfrm rot="16200000">
            <a:off x="2591690" y="479315"/>
            <a:ext cx="991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-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Z-s-W</a:t>
            </a:r>
            <a:endParaRPr lang="en-GB" sz="1600" dirty="0"/>
          </a:p>
        </p:txBody>
      </p:sp>
      <p:sp>
        <p:nvSpPr>
          <p:cNvPr id="47" name="TextBox 46"/>
          <p:cNvSpPr txBox="1"/>
          <p:nvPr/>
        </p:nvSpPr>
        <p:spPr>
          <a:xfrm rot="16200000">
            <a:off x="2829009" y="368347"/>
            <a:ext cx="1213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-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Z-m-W</a:t>
            </a:r>
            <a:endParaRPr lang="en-GB" sz="1600" dirty="0"/>
          </a:p>
        </p:txBody>
      </p:sp>
      <p:sp>
        <p:nvSpPr>
          <p:cNvPr id="48" name="TextBox 47"/>
          <p:cNvSpPr txBox="1"/>
          <p:nvPr/>
        </p:nvSpPr>
        <p:spPr>
          <a:xfrm rot="16200000">
            <a:off x="3177297" y="368347"/>
            <a:ext cx="12137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p-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Z-</a:t>
            </a:r>
            <a:r>
              <a:rPr lang="en-GB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g</a:t>
            </a:r>
            <a:r>
              <a:rPr lang="en-GB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-W</a:t>
            </a:r>
            <a:endParaRPr lang="en-GB" sz="1600" dirty="0"/>
          </a:p>
        </p:txBody>
      </p:sp>
      <p:grpSp>
        <p:nvGrpSpPr>
          <p:cNvPr id="3" name="Group 2"/>
          <p:cNvGrpSpPr/>
          <p:nvPr/>
        </p:nvGrpSpPr>
        <p:grpSpPr>
          <a:xfrm>
            <a:off x="1429392" y="3054011"/>
            <a:ext cx="3527532" cy="1196103"/>
            <a:chOff x="1013911" y="668472"/>
            <a:chExt cx="3527532" cy="1196103"/>
          </a:xfrm>
        </p:grpSpPr>
        <p:sp>
          <p:nvSpPr>
            <p:cNvPr id="4" name="Rectangle 3"/>
            <p:cNvSpPr/>
            <p:nvPr/>
          </p:nvSpPr>
          <p:spPr>
            <a:xfrm>
              <a:off x="3101443" y="1139249"/>
              <a:ext cx="1440000" cy="25905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i="1" dirty="0" err="1" smtClean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t</a:t>
              </a:r>
              <a:r>
                <a:rPr lang="en-GB" sz="1400" dirty="0" err="1" smtClean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</a:t>
              </a:r>
              <a:endParaRPr lang="en-GB" sz="1400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Rectangle 6"/>
            <p:cNvSpPr/>
            <p:nvPr/>
          </p:nvSpPr>
          <p:spPr>
            <a:xfrm>
              <a:off x="1013911" y="1139249"/>
              <a:ext cx="1440000" cy="25923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sz="1400" i="1" dirty="0" err="1" smtClean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rt</a:t>
              </a:r>
              <a:r>
                <a:rPr lang="en-GB" sz="1400" dirty="0" err="1" smtClean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</a:t>
              </a:r>
              <a:endParaRPr lang="en-GB" sz="1400" dirty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Rectangle 7"/>
            <p:cNvSpPr/>
            <p:nvPr/>
          </p:nvSpPr>
          <p:spPr>
            <a:xfrm>
              <a:off x="2451052" y="1139249"/>
              <a:ext cx="650391" cy="259050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GB" sz="10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INKER</a:t>
              </a:r>
              <a:endParaRPr lang="en-GB" sz="1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6" name="Straight Arrow Connector 15"/>
            <p:cNvCxnSpPr/>
            <p:nvPr/>
          </p:nvCxnSpPr>
          <p:spPr>
            <a:xfrm>
              <a:off x="1276964" y="992310"/>
              <a:ext cx="3600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/>
            <p:cNvCxnSpPr/>
            <p:nvPr/>
          </p:nvCxnSpPr>
          <p:spPr>
            <a:xfrm flipH="1">
              <a:off x="3960395" y="992310"/>
              <a:ext cx="3600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/>
            <p:cNvCxnSpPr/>
            <p:nvPr/>
          </p:nvCxnSpPr>
          <p:spPr>
            <a:xfrm>
              <a:off x="3378643" y="992310"/>
              <a:ext cx="3600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/>
            <p:cNvCxnSpPr/>
            <p:nvPr/>
          </p:nvCxnSpPr>
          <p:spPr>
            <a:xfrm flipH="1">
              <a:off x="1820876" y="992310"/>
              <a:ext cx="3600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/>
            <p:cNvCxnSpPr/>
            <p:nvPr/>
          </p:nvCxnSpPr>
          <p:spPr>
            <a:xfrm>
              <a:off x="2063770" y="1516828"/>
              <a:ext cx="3600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/>
            <p:cNvCxnSpPr/>
            <p:nvPr/>
          </p:nvCxnSpPr>
          <p:spPr>
            <a:xfrm flipH="1">
              <a:off x="3183689" y="1516828"/>
              <a:ext cx="3600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type="none" w="med" len="med"/>
              <a:tailEnd type="arrow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TextBox 48"/>
            <p:cNvSpPr txBox="1"/>
            <p:nvPr/>
          </p:nvSpPr>
          <p:spPr>
            <a:xfrm>
              <a:off x="1130417" y="682351"/>
              <a:ext cx="6530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-F</a:t>
              </a:r>
              <a:endParaRPr lang="en-GB" sz="16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1733911" y="682351"/>
              <a:ext cx="6530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-R</a:t>
              </a:r>
              <a:endParaRPr lang="en-GB" sz="16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252705" y="668472"/>
              <a:ext cx="6530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-F</a:t>
              </a:r>
              <a:endParaRPr lang="en-GB" sz="16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3856199" y="668472"/>
              <a:ext cx="65309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-R</a:t>
              </a:r>
              <a:endParaRPr lang="en-GB" sz="16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1697410" y="1526021"/>
              <a:ext cx="9841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_link</a:t>
              </a:r>
              <a:r>
                <a:rPr lang="en-GB" sz="16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F</a:t>
              </a:r>
              <a:endParaRPr lang="en-GB" sz="16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2921649" y="1526021"/>
              <a:ext cx="98414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dirty="0" err="1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_link</a:t>
              </a:r>
              <a:r>
                <a:rPr lang="en-GB" sz="1600" dirty="0" smtClean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R</a:t>
              </a:r>
              <a:endParaRPr lang="en-GB" sz="1600" dirty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7" name="TextBox 56"/>
          <p:cNvSpPr txBox="1"/>
          <p:nvPr/>
        </p:nvSpPr>
        <p:spPr>
          <a:xfrm>
            <a:off x="517998" y="4463716"/>
            <a:ext cx="1119816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6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600" b="1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.</a:t>
            </a:r>
            <a:r>
              <a:rPr kumimoji="0" lang="en-GB" sz="1600" b="1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 3. </a:t>
            </a:r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tection of the fused mRNA in the </a:t>
            </a:r>
            <a:r>
              <a:rPr lang="en-GB" sz="1600" kern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Z</a:t>
            </a:r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W </a:t>
            </a:r>
            <a:r>
              <a:rPr lang="en-GB" sz="1600" i="1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. benthamiana </a:t>
            </a:r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gro-infiltrated leaves. RT-PCR was performed using the following pair of primers: Z-F and Z-R; W-F and W-R; Z-F and W-R; </a:t>
            </a:r>
            <a:r>
              <a:rPr lang="en-GB" sz="1600" kern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Z_link</a:t>
            </a:r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F and </a:t>
            </a:r>
            <a:r>
              <a:rPr lang="en-GB" sz="1600" kern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W_link</a:t>
            </a:r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R and Actin-F and Actin-R. a) Photographs of RT-PCR product ran on a 1% agarose gel. On the left, primers used; on top, constructs agro-infiltrated; on the right, sizes of the bands, from left to right (if several). b) Scheme displaying the position of the primers used. p-Ø, empty vector; </a:t>
            </a:r>
            <a:r>
              <a:rPr lang="en-GB" sz="1600" kern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Z+W</a:t>
            </a:r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individual Z &amp; W ; </a:t>
            </a:r>
            <a:r>
              <a:rPr lang="en-GB" sz="1600" kern="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Z</a:t>
            </a:r>
            <a:r>
              <a:rPr lang="en-GB" sz="1600" kern="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W, Z &amp;W fusions with small, medium and long linker. c) Sequences of primers. </a:t>
            </a:r>
          </a:p>
          <a:p>
            <a:pPr marL="0" marR="0" lvl="0" indent="0" algn="just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6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21534" y="238429"/>
            <a:ext cx="6766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a)</a:t>
            </a:r>
            <a:endParaRPr lang="en-GB" dirty="0"/>
          </a:p>
        </p:txBody>
      </p:sp>
      <p:sp>
        <p:nvSpPr>
          <p:cNvPr id="44" name="TextBox 43"/>
          <p:cNvSpPr txBox="1"/>
          <p:nvPr/>
        </p:nvSpPr>
        <p:spPr>
          <a:xfrm>
            <a:off x="721532" y="3469647"/>
            <a:ext cx="420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b)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4184281" y="723932"/>
            <a:ext cx="987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u="sng" dirty="0" smtClean="0">
                <a:solidFill>
                  <a:schemeClr val="bg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izes</a:t>
            </a:r>
            <a:endParaRPr lang="en-GB" sz="1600" u="sng" dirty="0">
              <a:solidFill>
                <a:schemeClr val="bg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398171" y="723932"/>
            <a:ext cx="98755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u="sng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ers</a:t>
            </a:r>
            <a:endParaRPr lang="en-GB" sz="1600" u="sng" dirty="0">
              <a:solidFill>
                <a:schemeClr val="tx1">
                  <a:lumMod val="75000"/>
                  <a:lumOff val="2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6820303" y="338007"/>
            <a:ext cx="4205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smtClean="0"/>
              <a:t>c)</a:t>
            </a:r>
            <a:endParaRPr lang="en-GB" dirty="0"/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6148595"/>
              </p:ext>
            </p:extLst>
          </p:nvPr>
        </p:nvGraphicFramePr>
        <p:xfrm>
          <a:off x="7240894" y="479676"/>
          <a:ext cx="3404970" cy="1303020"/>
        </p:xfrm>
        <a:graphic>
          <a:graphicData uri="http://schemas.openxmlformats.org/drawingml/2006/table">
            <a:tbl>
              <a:tblPr/>
              <a:tblGrid>
                <a:gridCol w="947775"/>
                <a:gridCol w="2457195"/>
              </a:tblGrid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-F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atgcatggtttcctttggtc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-R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caaggccaaagatgaagtc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W-F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tggcttcctcacagacacac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W-R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tctccaccaaggtctcca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Z_link-F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ggggatcttcttctagcgg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82880"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W_link-R</a:t>
                      </a: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</a:rPr>
                        <a:t>cagcaacgatcattccagca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</a:endParaRPr>
                    </a:p>
                  </a:txBody>
                  <a:tcPr marL="3810" marR="3810" marT="381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795223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60</TotalTime>
  <Words>206</Words>
  <Application>Microsoft Office PowerPoint</Application>
  <PresentationFormat>Widescreen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  <Template/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